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2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23"/>
  </p:notesMasterIdLst>
  <p:sldIdLst>
    <p:sldId id="286" r:id="rId2"/>
    <p:sldId id="276" r:id="rId3"/>
    <p:sldId id="277" r:id="rId4"/>
    <p:sldId id="278" r:id="rId5"/>
    <p:sldId id="279" r:id="rId6"/>
    <p:sldId id="280" r:id="rId7"/>
    <p:sldId id="281" r:id="rId8"/>
    <p:sldId id="282" r:id="rId9"/>
    <p:sldId id="283" r:id="rId10"/>
    <p:sldId id="284" r:id="rId11"/>
    <p:sldId id="285" r:id="rId12"/>
    <p:sldId id="275" r:id="rId13"/>
    <p:sldId id="274" r:id="rId14"/>
    <p:sldId id="273" r:id="rId15"/>
    <p:sldId id="272" r:id="rId16"/>
    <p:sldId id="271" r:id="rId17"/>
    <p:sldId id="270" r:id="rId18"/>
    <p:sldId id="269" r:id="rId19"/>
    <p:sldId id="268" r:id="rId20"/>
    <p:sldId id="267" r:id="rId21"/>
    <p:sldId id="266" r:id="rId2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1348"/>
    <p:restoredTop sz="86667"/>
  </p:normalViewPr>
  <p:slideViewPr>
    <p:cSldViewPr snapToGrid="0" snapToObjects="1">
      <p:cViewPr varScale="1">
        <p:scale>
          <a:sx n="106" d="100"/>
          <a:sy n="106" d="100"/>
        </p:scale>
        <p:origin x="232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285F160-CC85-254C-9587-0437081D6E40}" type="datetimeFigureOut">
              <a:rPr lang="en-US" smtClean="0"/>
              <a:t>3/21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A007A61-2138-1841-A1FC-FC84BB4A4E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12922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2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A007A61-2138-1841-A1FC-FC84BB4A4E3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0420147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OVID OP Topic 8: Obvious concern for overdose patients—Narcan, drug overdose, resp failure, and heroin dependence terms; (is the size of “Falls” a matter of nurses documenting concern for falls over and over?)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A007A61-2138-1841-A1FC-FC84BB4A4E3C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484225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OVID OP Topic 9: Harder – </a:t>
            </a:r>
            <a:r>
              <a:rPr lang="en-US" dirty="0" err="1"/>
              <a:t>hodge</a:t>
            </a:r>
            <a:r>
              <a:rPr lang="en-US" dirty="0"/>
              <a:t> podge of any inpatient setting: some chronic illness, some infection. Nothing screams COVID or substance use besides Naloxone. (Why is naloxone present but nothing related to opioids? Part of education?)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A007A61-2138-1841-A1FC-FC84BB4A4E3C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3157712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OV Non-OP Topic 0: Classic hospitalized COVID patient w/typical comorbidities that might increase severity of COVID (</a:t>
            </a:r>
            <a:r>
              <a:rPr lang="en-US" dirty="0" err="1"/>
              <a:t>ct</a:t>
            </a:r>
            <a:r>
              <a:rPr lang="en-US" dirty="0"/>
              <a:t> chest, contrast media, diabetes </a:t>
            </a:r>
            <a:r>
              <a:rPr lang="en-US" dirty="0" err="1"/>
              <a:t>etc</a:t>
            </a:r>
            <a:r>
              <a:rPr lang="en-US" dirty="0"/>
              <a:t>)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 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orrection Re: “</a:t>
            </a:r>
            <a:r>
              <a:rPr lang="en-US" dirty="0" err="1"/>
              <a:t>bstructive</a:t>
            </a:r>
            <a:r>
              <a:rPr lang="en-US" dirty="0"/>
              <a:t>” = sleep apnea, obstructiv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A007A61-2138-1841-A1FC-FC84BB4A4E3C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9347823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OV Non-OP Topic 1: Sepsis-related terms (transient ischemic attack and eye drops throwing off panel) but less clearly COVID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A007A61-2138-1841-A1FC-FC84BB4A4E3C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6370034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OV Non-OP Topic 2: A lot of ordering procedures – prominent terms more obviously tied to COVID and also moderate to severe neuro-related (infusion, CVA, angiogram);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A007A61-2138-1841-A1FC-FC84BB4A4E3C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9541823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OV Non-OP Topic 3: Long-term ICU patients, severe disease w/discharge to </a:t>
            </a:r>
            <a:r>
              <a:rPr lang="en-US" dirty="0" err="1"/>
              <a:t>ltac</a:t>
            </a:r>
            <a:r>
              <a:rPr lang="en-US" dirty="0"/>
              <a:t> or </a:t>
            </a:r>
            <a:r>
              <a:rPr lang="en-US" dirty="0" err="1"/>
              <a:t>snf</a:t>
            </a:r>
            <a:r>
              <a:rPr lang="en-US" dirty="0"/>
              <a:t>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A007A61-2138-1841-A1FC-FC84BB4A4E3C}" type="slidenum">
              <a:rPr lang="en-US" smtClean="0"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2653808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OV Non-OP Topic 4: Acute respiratory failure – consistent w/COVID admission COPD, lung disease, giving Lasix, diuresis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A007A61-2138-1841-A1FC-FC84BB4A4E3C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7110185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OV Non-OP Topic 5: Standard COVID admission- hypoxia, resp failure, oxygen (DVT confusing – maybe prophylaxis documentation; also why does methamphetamine appear here and in a few other places?)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A007A61-2138-1841-A1FC-FC84BB4A4E3C}" type="slidenum">
              <a:rPr lang="en-US" smtClean="0"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0005510"/>
      </p:ext>
    </p:extLst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COV Non-OP Topic 6: Neuro-related terms – not often related to COVID admission but more like a patient on a neuro floor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A007A61-2138-1841-A1FC-FC84BB4A4E3C}" type="slidenum">
              <a:rPr lang="en-US" smtClean="0"/>
              <a:t>1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8118370"/>
      </p:ext>
    </p:extLst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COV Non-OP Topic 7: A lot of terms associated with chronic conditions that are also associated with more severe COVID; but not clear COVID-related terms here except fluid overload or </a:t>
            </a:r>
            <a:r>
              <a:rPr lang="en-US" dirty="0" err="1"/>
              <a:t>lasix</a:t>
            </a:r>
            <a:r>
              <a:rPr lang="en-US" dirty="0"/>
              <a:t>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A007A61-2138-1841-A1FC-FC84BB4A4E3C}" type="slidenum">
              <a:rPr lang="en-US" smtClean="0"/>
              <a:t>1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791977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COVID OP Topic 0: Chronically ill patients w/cardiac pulmonary; sicker w/more comorbidities at higher risk for COVID severity outcomes; methadone is only Med-assisted therapy indicating possible under-resourced patients as well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A007A61-2138-1841-A1FC-FC84BB4A4E3C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2502594"/>
      </p:ext>
    </p:extLst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Covid </a:t>
            </a:r>
            <a:r>
              <a:rPr lang="en-US" dirty="0" err="1"/>
              <a:t>NonOp</a:t>
            </a:r>
            <a:r>
              <a:rPr lang="en-US" dirty="0"/>
              <a:t> Topic 8: COVID-related terms common here that are “less severe” than past slides (why methamphetamine again – large font?)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A007A61-2138-1841-A1FC-FC84BB4A4E3C}" type="slidenum">
              <a:rPr lang="en-US" smtClean="0"/>
              <a:t>2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2399233"/>
      </p:ext>
    </p:extLst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COV Non-OP Topic 9: terms indicate chronic disease/illness (e.g. terminal cancer, transplant patients) that are associated with susceptibility to COVID but nothing outright aligned with COVID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A007A61-2138-1841-A1FC-FC84BB4A4E3C}" type="slidenum">
              <a:rPr lang="en-US" smtClean="0"/>
              <a:t>2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288601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COVID OP Topic 1: Topic is more heavily weighted toward substance misuse -- opioids/methadone/suboxone, cocaine -- and comorbidities associated with opioid misuse/IVDU – hepatitis, lesion, endocarditis, anxiety, pneumonia, risk for DVT. (Some questions around presence of morphology terms.)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A007A61-2138-1841-A1FC-FC84BB4A4E3C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600051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OVID OP Topic 2: Not a lot of substance misuse indicated here; a lot of cardio and renal pathology; first slide that mentions HIV-positive patients – HIV infections, Antiretroviral therapy-highly active, dapsone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A007A61-2138-1841-A1FC-FC84BB4A4E3C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753923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COVID OP Topic 3: Neurological-related workup terms perhaps for someone coming in with altered mental status – could be related to substance misuse. </a:t>
            </a:r>
            <a:r>
              <a:rPr lang="en-US" dirty="0" err="1"/>
              <a:t>Narca</a:t>
            </a:r>
            <a:r>
              <a:rPr lang="en-US" dirty="0"/>
              <a:t>, cocaine, fentanyl are present. (question around ‘Unable’ – term pulled in from a stroke scale perhaps?)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A007A61-2138-1841-A1FC-FC84BB4A4E3C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038626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OVID OP Topic 4: Also neuro issues with significant cardiac, blood coagulation disturbances (i.e. selenocysteine). Methadone is the only term related to substance misuse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A007A61-2138-1841-A1FC-FC84BB4A4E3C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8604815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OVID OP Topic 5: Very sick patients - look more like critical illness (e.g. cardiac arrest, malnutrition, severe, nutrition discussed a lot during hospitalization w/COVID), less specific to opioid misuse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A007A61-2138-1841-A1FC-FC84BB4A4E3C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6309988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OVID OP Topic 6 – Again toward respiratory/reactive airway terms and cardio-pulmonary disorders w/some opioid misuse (opioids, methadone). W/COVID and all the respiratory function issues combined with opioid misuse, could be extra risk for overdose among this group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A007A61-2138-1841-A1FC-FC84BB4A4E3C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5396745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COVID OP Topic 7: Clearly mix of terms reflecting chronic opioid misuse patients (opioids, naloxone, methadone, Narcan) with respiratory distress terms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A007A61-2138-1841-A1FC-FC84BB4A4E3C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21981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162F12-71AF-A642-A5DE-535781090F7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87CEA3D-ED38-174A-8B3D-8DF484461BC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4674D5-53F8-F047-AF2F-D65FE824DE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58B18-4467-4C48-BDB6-BBCE6A45CC05}" type="datetimeFigureOut">
              <a:rPr lang="en-US" smtClean="0"/>
              <a:t>3/2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2D14B1-A01E-DE4B-BEB3-547C2F7921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6E92DC-52CB-9741-8EA2-0D27F1349E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32693-E45D-6E40-877D-632669AF7C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50557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C11742-BBBD-2C4F-A684-3E5A77BBF5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5452BA9-9EE3-064B-874A-994C3C59E6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53D84E-AB13-9B43-A388-11EDEA62B9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58B18-4467-4C48-BDB6-BBCE6A45CC05}" type="datetimeFigureOut">
              <a:rPr lang="en-US" smtClean="0"/>
              <a:t>3/2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BC1775-B387-0C41-B6C1-FEF34E2AFC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751CD2-63A6-584F-BDE8-31B8FEC343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32693-E45D-6E40-877D-632669AF7C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72139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7613A36-2CB6-704A-97D4-177BA9D979E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7ABEADA-D594-E04B-B8D6-CE87DEDC87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6D6B90-ED7D-3C4C-B922-DFEEFCC9F8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58B18-4467-4C48-BDB6-BBCE6A45CC05}" type="datetimeFigureOut">
              <a:rPr lang="en-US" smtClean="0"/>
              <a:t>3/2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73A2DC-F44E-A143-9F0B-E0EBEE2898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2F2666-8EFD-3748-A4C1-5414CCBDB8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32693-E45D-6E40-877D-632669AF7C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95727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3509B0-EA55-F54F-B010-054AB6310E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EDEBFB4-4E69-0044-939B-DFA06CEB19D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F5F27E-1070-F149-8684-C8CCAF8571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58B18-4467-4C48-BDB6-BBCE6A45CC05}" type="datetimeFigureOut">
              <a:rPr lang="en-US" smtClean="0"/>
              <a:t>3/2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F821CB-DE20-1F40-B3DE-943CF1B2D4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A2997D-752B-104D-BA8E-1F00986F42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32693-E45D-6E40-877D-632669AF7C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33762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FAC4A3-0973-1240-B560-28838B2E8D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175AEEF-F967-B241-98D7-867F2A8EA8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BEE606-3AE9-3746-BC6C-A69800AFD4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58B18-4467-4C48-BDB6-BBCE6A45CC05}" type="datetimeFigureOut">
              <a:rPr lang="en-US" smtClean="0"/>
              <a:t>3/2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925676-916D-3240-B3A6-5AA2B5FED4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B91B9A-779D-2E4B-B638-B32E0C3D22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32693-E45D-6E40-877D-632669AF7C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50126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9DEFAC-60CD-CC4F-92C2-95F3BFDF97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D79A792-C9E3-E640-8DC1-655199E0677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E6C93E2-B035-7C40-ABCA-563447D754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C596C80-0879-4F4D-A484-2B2925C37B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58B18-4467-4C48-BDB6-BBCE6A45CC05}" type="datetimeFigureOut">
              <a:rPr lang="en-US" smtClean="0"/>
              <a:t>3/2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9714BDB-F4FD-2041-A498-7824F5D95F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7B52196-C442-BC4F-A150-64A5BD36DD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32693-E45D-6E40-877D-632669AF7C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68484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A33C8D-9D5A-3D4A-A495-8082D8F60E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FDE38D-963A-5C43-8347-C108329050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204AD8D-FE7C-B34F-A0A9-E4A334AA48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17DFF06-472C-C043-90D0-353DC780541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5430046-1930-DA47-BDD6-4237FEE971F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D7371AD-8BDE-5E4D-A0CA-8FC32E8AC0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58B18-4467-4C48-BDB6-BBCE6A45CC05}" type="datetimeFigureOut">
              <a:rPr lang="en-US" smtClean="0"/>
              <a:t>3/21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DD1DFE4-6F9D-6649-B4C0-CE112944A6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EE18BD5-7249-DC4E-A53B-76E8122661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32693-E45D-6E40-877D-632669AF7C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87325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BB949F-4011-1D4C-86C6-4CEE10B055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0F4033B-F0A8-2C45-948C-8FE62DBF9C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58B18-4467-4C48-BDB6-BBCE6A45CC05}" type="datetimeFigureOut">
              <a:rPr lang="en-US" smtClean="0"/>
              <a:t>3/21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0EAB6A7-C54E-9447-82D1-ED0A63EF78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54D1BDB-FE1D-6942-BB1A-3D10649DC3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32693-E45D-6E40-877D-632669AF7C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10589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E63A60B-1FCB-7C43-85E2-A6071A3ED1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58B18-4467-4C48-BDB6-BBCE6A45CC05}" type="datetimeFigureOut">
              <a:rPr lang="en-US" smtClean="0"/>
              <a:t>3/21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8C7212A-8EC3-3B4E-B6A7-8EBB2249E1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7FFA107-2920-5C42-97E7-F5B7E523D1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32693-E45D-6E40-877D-632669AF7C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65673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BEF501-8694-7849-9CAB-FBAF0184D2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2C29B8-201E-4E41-9A90-3FB79EA3299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32B93A0-0485-0544-9D1A-8B9F018D53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03A66F-7B7F-4A4B-A4CA-B93E775AF6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58B18-4467-4C48-BDB6-BBCE6A45CC05}" type="datetimeFigureOut">
              <a:rPr lang="en-US" smtClean="0"/>
              <a:t>3/2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F782A2E-216B-7F41-AE78-2A7C5D625F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3B9BA97-72E3-D44D-B528-2982D3E949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32693-E45D-6E40-877D-632669AF7C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82084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36DC97-EB8E-1E40-9085-29ED0EA3C5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B1B32D6-A820-DB4E-B76C-1B621AB5140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D71B277-0812-6A4E-85E1-6454E368186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345AB6-95AB-7E49-ABDE-F0F5CFD063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58B18-4467-4C48-BDB6-BBCE6A45CC05}" type="datetimeFigureOut">
              <a:rPr lang="en-US" smtClean="0"/>
              <a:t>3/2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866AB7-59B8-A94D-8CCD-374E233A74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41B66CC-3F66-DB43-AE5B-AC6AC92F5C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32693-E45D-6E40-877D-632669AF7C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71230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BFCE2E0-909F-2643-9632-D87C9A424F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D8B1B70-818F-A348-9580-B544A1DED5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32AFBF-7285-DA41-922A-17130FD4B0A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C58B18-4467-4C48-BDB6-BBCE6A45CC05}" type="datetimeFigureOut">
              <a:rPr lang="en-US" smtClean="0"/>
              <a:t>3/2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D78FAB-6A47-9B4F-A1F2-CEA85EC8A65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02EC9C-69A7-4842-9643-39AF847A908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032693-E45D-6E40-877D-632669AF7C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41597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notesSlide" Target="../notesSlides/notesSlide2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2E76BB-C803-0A4D-AD63-E67AB5EC1B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2488222"/>
            <a:ext cx="10515600" cy="1881555"/>
          </a:xfrm>
        </p:spPr>
        <p:txBody>
          <a:bodyPr>
            <a:normAutofit/>
          </a:bodyPr>
          <a:lstStyle/>
          <a:p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Topic modelling experiment to identify ten topics regarding the clinical </a:t>
            </a:r>
            <a:r>
              <a:rPr lang="en-US" sz="2000">
                <a:latin typeface="Times New Roman" panose="02020603050405020304" pitchFamily="18" charset="0"/>
                <a:cs typeface="Times New Roman" panose="02020603050405020304" pitchFamily="18" charset="0"/>
              </a:rPr>
              <a:t>presentations foreach of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wo subgroups (n=4,110) of a cohort of unplanned admissions at a Chicago academic health center between January 1 and December 31, 2020 (N = 32,635): 1) admissions with COVID-19 and unhealthy opioid use (COV-UOU, n=102) and 2) admissions with COVID-19 and no unhealthy opioid use (COV-NO-UOU, n=4,008).</a:t>
            </a:r>
          </a:p>
        </p:txBody>
      </p:sp>
    </p:spTree>
    <p:extLst>
      <p:ext uri="{BB962C8B-B14F-4D97-AF65-F5344CB8AC3E}">
        <p14:creationId xmlns:p14="http://schemas.microsoft.com/office/powerpoint/2010/main" val="46513873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picture containing text&#10;&#10;Description automatically generated">
            <a:extLst>
              <a:ext uri="{FF2B5EF4-FFF2-40B4-BE49-F238E27FC236}">
                <a16:creationId xmlns:a16="http://schemas.microsoft.com/office/drawing/2014/main" id="{2184539F-1D3A-0B4E-87E7-33CAFA9C5E3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7145" y="685800"/>
            <a:ext cx="11117710" cy="54864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78EFC0A-6358-1E47-9B06-96BCC17777BC}"/>
              </a:ext>
            </a:extLst>
          </p:cNvPr>
          <p:cNvSpPr txBox="1"/>
          <p:nvPr/>
        </p:nvSpPr>
        <p:spPr>
          <a:xfrm>
            <a:off x="821410" y="325464"/>
            <a:ext cx="121456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COV-UOU</a:t>
            </a:r>
          </a:p>
        </p:txBody>
      </p:sp>
    </p:spTree>
    <p:extLst>
      <p:ext uri="{BB962C8B-B14F-4D97-AF65-F5344CB8AC3E}">
        <p14:creationId xmlns:p14="http://schemas.microsoft.com/office/powerpoint/2010/main" val="118399198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">
            <a:extLst>
              <a:ext uri="{FF2B5EF4-FFF2-40B4-BE49-F238E27FC236}">
                <a16:creationId xmlns:a16="http://schemas.microsoft.com/office/drawing/2014/main" id="{705D481F-045B-634E-88B5-87932D06E10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8743" y="685800"/>
            <a:ext cx="10854514" cy="54864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0664459-4F76-9848-BF9C-E0EA05BAF080}"/>
              </a:ext>
            </a:extLst>
          </p:cNvPr>
          <p:cNvSpPr txBox="1"/>
          <p:nvPr/>
        </p:nvSpPr>
        <p:spPr>
          <a:xfrm>
            <a:off x="821410" y="325464"/>
            <a:ext cx="121456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COV-UOU</a:t>
            </a:r>
          </a:p>
        </p:txBody>
      </p:sp>
    </p:spTree>
    <p:extLst>
      <p:ext uri="{BB962C8B-B14F-4D97-AF65-F5344CB8AC3E}">
        <p14:creationId xmlns:p14="http://schemas.microsoft.com/office/powerpoint/2010/main" val="411869867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, letter&#10;&#10;Description automatically generated">
            <a:extLst>
              <a:ext uri="{FF2B5EF4-FFF2-40B4-BE49-F238E27FC236}">
                <a16:creationId xmlns:a16="http://schemas.microsoft.com/office/drawing/2014/main" id="{A9BFDEFF-6381-1749-A990-7EB7568EF23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2326" y="697992"/>
            <a:ext cx="10687348" cy="54864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461CA1AA-AF67-9147-BB81-34AAFA348418}"/>
              </a:ext>
            </a:extLst>
          </p:cNvPr>
          <p:cNvSpPr txBox="1"/>
          <p:nvPr/>
        </p:nvSpPr>
        <p:spPr>
          <a:xfrm>
            <a:off x="821410" y="325464"/>
            <a:ext cx="16345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COV-NO-UOU</a:t>
            </a:r>
          </a:p>
        </p:txBody>
      </p:sp>
    </p:spTree>
    <p:extLst>
      <p:ext uri="{BB962C8B-B14F-4D97-AF65-F5344CB8AC3E}">
        <p14:creationId xmlns:p14="http://schemas.microsoft.com/office/powerpoint/2010/main" val="128660850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Text&#10;&#10;Description automatically generated">
            <a:extLst>
              <a:ext uri="{FF2B5EF4-FFF2-40B4-BE49-F238E27FC236}">
                <a16:creationId xmlns:a16="http://schemas.microsoft.com/office/drawing/2014/main" id="{D5D1E965-0C26-F94C-BE00-89E58612C57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0701" y="685800"/>
            <a:ext cx="10870598" cy="54864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93E726D-3959-474E-BA59-8EA64082E7A4}"/>
              </a:ext>
            </a:extLst>
          </p:cNvPr>
          <p:cNvSpPr txBox="1"/>
          <p:nvPr/>
        </p:nvSpPr>
        <p:spPr>
          <a:xfrm>
            <a:off x="821410" y="325464"/>
            <a:ext cx="16345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COV-NO-UOU</a:t>
            </a:r>
          </a:p>
        </p:txBody>
      </p:sp>
    </p:spTree>
    <p:extLst>
      <p:ext uri="{BB962C8B-B14F-4D97-AF65-F5344CB8AC3E}">
        <p14:creationId xmlns:p14="http://schemas.microsoft.com/office/powerpoint/2010/main" val="169019264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Text&#10;&#10;Description automatically generated">
            <a:extLst>
              <a:ext uri="{FF2B5EF4-FFF2-40B4-BE49-F238E27FC236}">
                <a16:creationId xmlns:a16="http://schemas.microsoft.com/office/drawing/2014/main" id="{A5F77CFA-F76F-274F-882C-8A42F39F882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1959" y="685800"/>
            <a:ext cx="11008082" cy="54864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9BB304E9-B0C6-6643-8EB7-5DCD3689DDF1}"/>
              </a:ext>
            </a:extLst>
          </p:cNvPr>
          <p:cNvSpPr txBox="1"/>
          <p:nvPr/>
        </p:nvSpPr>
        <p:spPr>
          <a:xfrm>
            <a:off x="821410" y="325464"/>
            <a:ext cx="16345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COV-NO-UOU</a:t>
            </a:r>
          </a:p>
        </p:txBody>
      </p:sp>
    </p:spTree>
    <p:extLst>
      <p:ext uri="{BB962C8B-B14F-4D97-AF65-F5344CB8AC3E}">
        <p14:creationId xmlns:p14="http://schemas.microsoft.com/office/powerpoint/2010/main" val="416235239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Text&#10;&#10;Description automatically generated">
            <a:extLst>
              <a:ext uri="{FF2B5EF4-FFF2-40B4-BE49-F238E27FC236}">
                <a16:creationId xmlns:a16="http://schemas.microsoft.com/office/drawing/2014/main" id="{76459A15-D47F-A649-BAA5-88D71904C56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4907" y="685800"/>
            <a:ext cx="10982186" cy="54864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130A193-0846-4144-B992-77CB36B4E315}"/>
              </a:ext>
            </a:extLst>
          </p:cNvPr>
          <p:cNvSpPr txBox="1"/>
          <p:nvPr/>
        </p:nvSpPr>
        <p:spPr>
          <a:xfrm>
            <a:off x="821410" y="325464"/>
            <a:ext cx="16345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COV-NO-UOU</a:t>
            </a:r>
          </a:p>
        </p:txBody>
      </p:sp>
    </p:spTree>
    <p:extLst>
      <p:ext uri="{BB962C8B-B14F-4D97-AF65-F5344CB8AC3E}">
        <p14:creationId xmlns:p14="http://schemas.microsoft.com/office/powerpoint/2010/main" val="182878754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9316E9F-95CE-614C-9480-DCD78146DB0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7827" y="685800"/>
            <a:ext cx="10936346" cy="54864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15AB90E-E4A4-3E4C-A4B1-7CF27B55EEA9}"/>
              </a:ext>
            </a:extLst>
          </p:cNvPr>
          <p:cNvSpPr txBox="1"/>
          <p:nvPr/>
        </p:nvSpPr>
        <p:spPr>
          <a:xfrm>
            <a:off x="821410" y="325464"/>
            <a:ext cx="16345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COV-NO-UOU</a:t>
            </a:r>
          </a:p>
        </p:txBody>
      </p:sp>
    </p:spTree>
    <p:extLst>
      <p:ext uri="{BB962C8B-B14F-4D97-AF65-F5344CB8AC3E}">
        <p14:creationId xmlns:p14="http://schemas.microsoft.com/office/powerpoint/2010/main" val="896743934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Text&#10;&#10;Description automatically generated">
            <a:extLst>
              <a:ext uri="{FF2B5EF4-FFF2-40B4-BE49-F238E27FC236}">
                <a16:creationId xmlns:a16="http://schemas.microsoft.com/office/drawing/2014/main" id="{5CAF2C60-9260-A744-A1D8-516179C5AE9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9314" y="685800"/>
            <a:ext cx="10813372" cy="54864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A889F11-8E32-4346-B341-50A47C76130F}"/>
              </a:ext>
            </a:extLst>
          </p:cNvPr>
          <p:cNvSpPr txBox="1"/>
          <p:nvPr/>
        </p:nvSpPr>
        <p:spPr>
          <a:xfrm>
            <a:off x="821410" y="325464"/>
            <a:ext cx="16345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COV-NO-UOU</a:t>
            </a:r>
          </a:p>
        </p:txBody>
      </p:sp>
    </p:spTree>
    <p:extLst>
      <p:ext uri="{BB962C8B-B14F-4D97-AF65-F5344CB8AC3E}">
        <p14:creationId xmlns:p14="http://schemas.microsoft.com/office/powerpoint/2010/main" val="209900091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Text&#10;&#10;Description automatically generated">
            <a:extLst>
              <a:ext uri="{FF2B5EF4-FFF2-40B4-BE49-F238E27FC236}">
                <a16:creationId xmlns:a16="http://schemas.microsoft.com/office/drawing/2014/main" id="{3F6E691A-A854-CA47-B36D-6CCC5B1B0E6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5270" y="685800"/>
            <a:ext cx="10921460" cy="54864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7674BB3-C09C-1049-8D6C-63009E921D3C}"/>
              </a:ext>
            </a:extLst>
          </p:cNvPr>
          <p:cNvSpPr txBox="1"/>
          <p:nvPr/>
        </p:nvSpPr>
        <p:spPr>
          <a:xfrm>
            <a:off x="821410" y="325464"/>
            <a:ext cx="16345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COV-NO-UOU</a:t>
            </a:r>
          </a:p>
        </p:txBody>
      </p:sp>
    </p:spTree>
    <p:extLst>
      <p:ext uri="{BB962C8B-B14F-4D97-AF65-F5344CB8AC3E}">
        <p14:creationId xmlns:p14="http://schemas.microsoft.com/office/powerpoint/2010/main" val="3592345936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Text&#10;&#10;Description automatically generated">
            <a:extLst>
              <a:ext uri="{FF2B5EF4-FFF2-40B4-BE49-F238E27FC236}">
                <a16:creationId xmlns:a16="http://schemas.microsoft.com/office/drawing/2014/main" id="{18139E4A-33D3-4C4A-8B3B-CD9AE050B34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70061" y="685800"/>
            <a:ext cx="10651878" cy="54864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501BEC14-307D-4A40-AC98-C83BA5C8ACE4}"/>
              </a:ext>
            </a:extLst>
          </p:cNvPr>
          <p:cNvSpPr txBox="1"/>
          <p:nvPr/>
        </p:nvSpPr>
        <p:spPr>
          <a:xfrm>
            <a:off x="821410" y="325464"/>
            <a:ext cx="16345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COV-NO-UOU</a:t>
            </a:r>
          </a:p>
        </p:txBody>
      </p:sp>
    </p:spTree>
    <p:extLst>
      <p:ext uri="{BB962C8B-B14F-4D97-AF65-F5344CB8AC3E}">
        <p14:creationId xmlns:p14="http://schemas.microsoft.com/office/powerpoint/2010/main" val="3401454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Text&#10;&#10;Description automatically generated">
            <a:extLst>
              <a:ext uri="{FF2B5EF4-FFF2-40B4-BE49-F238E27FC236}">
                <a16:creationId xmlns:a16="http://schemas.microsoft.com/office/drawing/2014/main" id="{F4A8DDE3-6F88-A144-BD15-5568EDF6A4F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7500" y="685800"/>
            <a:ext cx="11136999" cy="54864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16A228F0-DB48-C14E-9867-679D3F7A2488}"/>
              </a:ext>
            </a:extLst>
          </p:cNvPr>
          <p:cNvSpPr txBox="1"/>
          <p:nvPr/>
        </p:nvSpPr>
        <p:spPr>
          <a:xfrm>
            <a:off x="821410" y="325464"/>
            <a:ext cx="121456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COV-UOU</a:t>
            </a:r>
          </a:p>
        </p:txBody>
      </p:sp>
    </p:spTree>
    <p:extLst>
      <p:ext uri="{BB962C8B-B14F-4D97-AF65-F5344CB8AC3E}">
        <p14:creationId xmlns:p14="http://schemas.microsoft.com/office/powerpoint/2010/main" val="2781849507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Text&#10;&#10;Description automatically generated">
            <a:extLst>
              <a:ext uri="{FF2B5EF4-FFF2-40B4-BE49-F238E27FC236}">
                <a16:creationId xmlns:a16="http://schemas.microsoft.com/office/drawing/2014/main" id="{9DD609AB-EF2F-4442-94E1-DB480DE00C2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1682" y="685800"/>
            <a:ext cx="11328635" cy="54864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873288B-5918-BA41-BD6B-1C6E73BCD50E}"/>
              </a:ext>
            </a:extLst>
          </p:cNvPr>
          <p:cNvSpPr txBox="1"/>
          <p:nvPr/>
        </p:nvSpPr>
        <p:spPr>
          <a:xfrm>
            <a:off x="821410" y="325464"/>
            <a:ext cx="16345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COV-NO-UOU</a:t>
            </a:r>
          </a:p>
        </p:txBody>
      </p:sp>
    </p:spTree>
    <p:extLst>
      <p:ext uri="{BB962C8B-B14F-4D97-AF65-F5344CB8AC3E}">
        <p14:creationId xmlns:p14="http://schemas.microsoft.com/office/powerpoint/2010/main" val="2145650011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Text&#10;&#10;Description automatically generated">
            <a:extLst>
              <a:ext uri="{FF2B5EF4-FFF2-40B4-BE49-F238E27FC236}">
                <a16:creationId xmlns:a16="http://schemas.microsoft.com/office/drawing/2014/main" id="{29AF9275-B865-B146-95C9-BFE972E1803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5373" y="685800"/>
            <a:ext cx="10761254" cy="54864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418CAD81-8075-8D44-8C12-7A0EFC300DB7}"/>
              </a:ext>
            </a:extLst>
          </p:cNvPr>
          <p:cNvSpPr txBox="1"/>
          <p:nvPr/>
        </p:nvSpPr>
        <p:spPr>
          <a:xfrm>
            <a:off x="821410" y="325464"/>
            <a:ext cx="16345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COV-NO-UOU</a:t>
            </a:r>
          </a:p>
        </p:txBody>
      </p:sp>
    </p:spTree>
    <p:extLst>
      <p:ext uri="{BB962C8B-B14F-4D97-AF65-F5344CB8AC3E}">
        <p14:creationId xmlns:p14="http://schemas.microsoft.com/office/powerpoint/2010/main" val="34638211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">
            <a:extLst>
              <a:ext uri="{FF2B5EF4-FFF2-40B4-BE49-F238E27FC236}">
                <a16:creationId xmlns:a16="http://schemas.microsoft.com/office/drawing/2014/main" id="{D008295F-F13F-854B-9E9F-BD6A78CFC89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4907" y="685800"/>
            <a:ext cx="10982186" cy="54864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5CD6F6C-45D7-AF49-81C7-CE4CC6F0F862}"/>
              </a:ext>
            </a:extLst>
          </p:cNvPr>
          <p:cNvSpPr txBox="1"/>
          <p:nvPr/>
        </p:nvSpPr>
        <p:spPr>
          <a:xfrm>
            <a:off x="821410" y="325464"/>
            <a:ext cx="121456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COV-UOU</a:t>
            </a:r>
          </a:p>
        </p:txBody>
      </p:sp>
    </p:spTree>
    <p:extLst>
      <p:ext uri="{BB962C8B-B14F-4D97-AF65-F5344CB8AC3E}">
        <p14:creationId xmlns:p14="http://schemas.microsoft.com/office/powerpoint/2010/main" val="333277716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6B336CC-A32D-774E-B396-B75F3CCA2C4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6745" y="685800"/>
            <a:ext cx="10938510" cy="54864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E5192DA-D842-9A40-B078-D7E40BE35A77}"/>
              </a:ext>
            </a:extLst>
          </p:cNvPr>
          <p:cNvSpPr txBox="1"/>
          <p:nvPr/>
        </p:nvSpPr>
        <p:spPr>
          <a:xfrm>
            <a:off x="821410" y="325464"/>
            <a:ext cx="121456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COV-UOU</a:t>
            </a:r>
          </a:p>
        </p:txBody>
      </p:sp>
    </p:spTree>
    <p:extLst>
      <p:ext uri="{BB962C8B-B14F-4D97-AF65-F5344CB8AC3E}">
        <p14:creationId xmlns:p14="http://schemas.microsoft.com/office/powerpoint/2010/main" val="134950761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Text&#10;&#10;Description automatically generated">
            <a:extLst>
              <a:ext uri="{FF2B5EF4-FFF2-40B4-BE49-F238E27FC236}">
                <a16:creationId xmlns:a16="http://schemas.microsoft.com/office/drawing/2014/main" id="{16339814-29B2-B344-B9C6-A215F9DC774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4745" y="685800"/>
            <a:ext cx="11602509" cy="54864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F7E85B6-FAF5-4244-AF1F-131F6BC00D7B}"/>
              </a:ext>
            </a:extLst>
          </p:cNvPr>
          <p:cNvSpPr txBox="1"/>
          <p:nvPr/>
        </p:nvSpPr>
        <p:spPr>
          <a:xfrm>
            <a:off x="821410" y="325464"/>
            <a:ext cx="121456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COV-UOU</a:t>
            </a:r>
          </a:p>
        </p:txBody>
      </p:sp>
    </p:spTree>
    <p:extLst>
      <p:ext uri="{BB962C8B-B14F-4D97-AF65-F5344CB8AC3E}">
        <p14:creationId xmlns:p14="http://schemas.microsoft.com/office/powerpoint/2010/main" val="95707249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Text&#10;&#10;Description automatically generated">
            <a:extLst>
              <a:ext uri="{FF2B5EF4-FFF2-40B4-BE49-F238E27FC236}">
                <a16:creationId xmlns:a16="http://schemas.microsoft.com/office/drawing/2014/main" id="{E926AE7B-9053-4B49-BE1B-1C222A111E1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8947" y="685800"/>
            <a:ext cx="10714105" cy="54864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12D3908-3410-C048-9A6F-F8CEEC2E514A}"/>
              </a:ext>
            </a:extLst>
          </p:cNvPr>
          <p:cNvSpPr txBox="1"/>
          <p:nvPr/>
        </p:nvSpPr>
        <p:spPr>
          <a:xfrm>
            <a:off x="821410" y="325464"/>
            <a:ext cx="121456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COV-UOU</a:t>
            </a:r>
          </a:p>
        </p:txBody>
      </p:sp>
    </p:spTree>
    <p:extLst>
      <p:ext uri="{BB962C8B-B14F-4D97-AF65-F5344CB8AC3E}">
        <p14:creationId xmlns:p14="http://schemas.microsoft.com/office/powerpoint/2010/main" val="5842162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Text&#10;&#10;Description automatically generated">
            <a:extLst>
              <a:ext uri="{FF2B5EF4-FFF2-40B4-BE49-F238E27FC236}">
                <a16:creationId xmlns:a16="http://schemas.microsoft.com/office/drawing/2014/main" id="{966C7BFA-CEC8-A840-8708-6B1C9CBC4F6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6761" y="685800"/>
            <a:ext cx="10838477" cy="54864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C703E0F-D3BD-A248-B98A-B25E4F41D6D5}"/>
              </a:ext>
            </a:extLst>
          </p:cNvPr>
          <p:cNvSpPr txBox="1"/>
          <p:nvPr/>
        </p:nvSpPr>
        <p:spPr>
          <a:xfrm>
            <a:off x="821410" y="325464"/>
            <a:ext cx="121456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COV-UOU</a:t>
            </a:r>
          </a:p>
        </p:txBody>
      </p:sp>
    </p:spTree>
    <p:extLst>
      <p:ext uri="{BB962C8B-B14F-4D97-AF65-F5344CB8AC3E}">
        <p14:creationId xmlns:p14="http://schemas.microsoft.com/office/powerpoint/2010/main" val="343383745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Text&#10;&#10;Description automatically generated">
            <a:extLst>
              <a:ext uri="{FF2B5EF4-FFF2-40B4-BE49-F238E27FC236}">
                <a16:creationId xmlns:a16="http://schemas.microsoft.com/office/drawing/2014/main" id="{9FE15434-3233-7B43-9FAC-5FDD44A60E6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2182" y="685800"/>
            <a:ext cx="10847635" cy="54864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B5631F7-8A8B-7945-8352-AF9A308BCDDE}"/>
              </a:ext>
            </a:extLst>
          </p:cNvPr>
          <p:cNvSpPr txBox="1"/>
          <p:nvPr/>
        </p:nvSpPr>
        <p:spPr>
          <a:xfrm>
            <a:off x="821410" y="325464"/>
            <a:ext cx="121456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COV-UOU</a:t>
            </a:r>
          </a:p>
        </p:txBody>
      </p:sp>
    </p:spTree>
    <p:extLst>
      <p:ext uri="{BB962C8B-B14F-4D97-AF65-F5344CB8AC3E}">
        <p14:creationId xmlns:p14="http://schemas.microsoft.com/office/powerpoint/2010/main" val="69783811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Text&#10;&#10;Description automatically generated">
            <a:extLst>
              <a:ext uri="{FF2B5EF4-FFF2-40B4-BE49-F238E27FC236}">
                <a16:creationId xmlns:a16="http://schemas.microsoft.com/office/drawing/2014/main" id="{FF626E1B-6363-9442-A734-CD223195BBC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2474" y="685800"/>
            <a:ext cx="10827051" cy="54864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03DD714-71E6-BC46-AE9E-3BF2FF4832DF}"/>
              </a:ext>
            </a:extLst>
          </p:cNvPr>
          <p:cNvSpPr txBox="1"/>
          <p:nvPr/>
        </p:nvSpPr>
        <p:spPr>
          <a:xfrm>
            <a:off x="821410" y="325464"/>
            <a:ext cx="121456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COV-UOU</a:t>
            </a:r>
          </a:p>
        </p:txBody>
      </p:sp>
    </p:spTree>
    <p:extLst>
      <p:ext uri="{BB962C8B-B14F-4D97-AF65-F5344CB8AC3E}">
        <p14:creationId xmlns:p14="http://schemas.microsoft.com/office/powerpoint/2010/main" val="6885930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444</TotalTime>
  <Words>833</Words>
  <Application>Microsoft Macintosh PowerPoint</Application>
  <PresentationFormat>Widescreen</PresentationFormat>
  <Paragraphs>65</Paragraphs>
  <Slides>21</Slides>
  <Notes>2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1</vt:i4>
      </vt:variant>
    </vt:vector>
  </HeadingPairs>
  <TitlesOfParts>
    <vt:vector size="26" baseType="lpstr">
      <vt:lpstr>Arial</vt:lpstr>
      <vt:lpstr>Calibri</vt:lpstr>
      <vt:lpstr>Calibri Light</vt:lpstr>
      <vt:lpstr>Times New Roman</vt:lpstr>
      <vt:lpstr>Office Theme</vt:lpstr>
      <vt:lpstr>Figure S2. Topic modelling experiment to identify ten topics regarding the clinical presentations foreach of two subgroups (n=4,110) of a cohort of unplanned admissions at a Chicago academic health center between January 1 and December 31, 2020 (N = 32,635): 1) admissions with COVID-19 and unhealthy opioid use (COV-UOU, n=102) and 2) admissions with COVID-19 and no unhealthy opioid use (COV-NO-UOU, n=4,008).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le Thompson</dc:creator>
  <cp:lastModifiedBy>Hale Thompson</cp:lastModifiedBy>
  <cp:revision>37</cp:revision>
  <cp:lastPrinted>2021-11-30T19:51:16Z</cp:lastPrinted>
  <dcterms:created xsi:type="dcterms:W3CDTF">2021-11-30T03:56:03Z</dcterms:created>
  <dcterms:modified xsi:type="dcterms:W3CDTF">2022-03-21T18:45:31Z</dcterms:modified>
</cp:coreProperties>
</file>